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D053B-01FF-4AA6-B8E6-5C8912F082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2EF1D-E44D-4996-A5E8-5D38AFEF9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03E37-4E7A-4B38-9568-1943073A63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2E475-0D84-4B3B-91F9-8376B7D71A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17FCA-3878-436C-A2DE-9E0FD9AD79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2A7C9-2315-4E8E-9CCF-FA2A3B3928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64FBB-3932-4FD7-AA45-53C70905D7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57FCD-B3FB-4987-9648-25BF93768B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13AB3-D53F-4F81-9BE3-BAD61A3FD3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63472-0E88-4F75-AA86-C9AF55481B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FBEC2-C120-4F18-8FF6-9D77779BD6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7AA7E-DF88-474F-B162-5E5003002D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002094-649A-49E9-9300-055E63ED0F1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1" descr=""/>
          <p:cNvPicPr/>
          <p:nvPr/>
        </p:nvPicPr>
        <p:blipFill>
          <a:blip r:embed="rId1"/>
          <a:stretch/>
        </p:blipFill>
        <p:spPr>
          <a:xfrm>
            <a:off x="609480" y="225360"/>
            <a:ext cx="8143920" cy="489600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990720" y="5416560"/>
            <a:ext cx="708660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5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O annotation of 762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F. virguliforme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roteins that are conserved across 25 diverse organisms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 large number of the conserved proteins control metabolic, cellular and developmental processe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Bhattacharyya, Madan K [AGRON]</dc:creator>
  <dc:description/>
  <dc:language>en-US</dc:language>
  <cp:lastModifiedBy>Bhattacharyya, Madan K [AGRON]</cp:lastModifiedBy>
  <dcterms:modified xsi:type="dcterms:W3CDTF">2013-06-09T21:29:19Z</dcterms:modified>
  <cp:revision>14</cp:revision>
  <dc:subject/>
  <dc:title>Slide 1</dc:title>
</cp:coreProperties>
</file>